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16" userDrawn="1">
          <p15:clr>
            <a:srgbClr val="A4A3A4"/>
          </p15:clr>
        </p15:guide>
        <p15:guide id="2" pos="579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67"/>
    <p:restoredTop sz="94564"/>
  </p:normalViewPr>
  <p:slideViewPr>
    <p:cSldViewPr snapToGrid="0" showGuides="1">
      <p:cViewPr varScale="1">
        <p:scale>
          <a:sx n="106" d="100"/>
          <a:sy n="106" d="100"/>
        </p:scale>
        <p:origin x="584" y="184"/>
      </p:cViewPr>
      <p:guideLst>
        <p:guide orient="horz" pos="1616"/>
        <p:guide pos="579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DE2852E-649B-2E4D-13AE-B206804638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5999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115B43D-7D92-6901-512B-ED8D9FA0A5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7" indent="0" algn="ctr">
              <a:buNone/>
              <a:defRPr sz="2000"/>
            </a:lvl2pPr>
            <a:lvl3pPr marL="914373" indent="0" algn="ctr">
              <a:buNone/>
              <a:defRPr sz="1801"/>
            </a:lvl3pPr>
            <a:lvl4pPr marL="1371560" indent="0" algn="ctr">
              <a:buNone/>
              <a:defRPr sz="1600"/>
            </a:lvl4pPr>
            <a:lvl5pPr marL="1828746" indent="0" algn="ctr">
              <a:buNone/>
              <a:defRPr sz="1600"/>
            </a:lvl5pPr>
            <a:lvl6pPr marL="2285933" indent="0" algn="ctr">
              <a:buNone/>
              <a:defRPr sz="1600"/>
            </a:lvl6pPr>
            <a:lvl7pPr marL="2743119" indent="0" algn="ctr">
              <a:buNone/>
              <a:defRPr sz="1600"/>
            </a:lvl7pPr>
            <a:lvl8pPr marL="3200306" indent="0" algn="ctr">
              <a:buNone/>
              <a:defRPr sz="1600"/>
            </a:lvl8pPr>
            <a:lvl9pPr marL="3657493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9DF4B04-3596-20F2-F346-C1C725B450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1CB8C-85E8-6441-8DB0-6274F310FB87}" type="datetimeFigureOut">
              <a:rPr lang="de-DE" smtClean="0"/>
              <a:t>20.11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7F22A6C-D94C-1D7E-88E0-23CDAD4D8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6FBB856-25CC-157A-D214-9BF7584FB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2128C-0E6E-FA46-AD2A-9E546E6645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26778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BC5B1CD-28A1-C5CE-2548-FC9EE21E90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BAAE5CE-5E66-7CC6-7225-7CE524E07C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88AD232-3E4B-7603-1B6F-E9547FE82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1CB8C-85E8-6441-8DB0-6274F310FB87}" type="datetimeFigureOut">
              <a:rPr lang="de-DE" smtClean="0"/>
              <a:t>20.11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EF38E60-09BA-9DEC-79AB-3E8C9C5C1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6B24E72-2459-5521-5193-70DDF72528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2128C-0E6E-FA46-AD2A-9E546E6645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8872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DDE093FC-9F81-D08B-8909-16D8379C66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5FCD196-10B3-8D93-ACA4-050E37B403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2034ACB-AD96-B1B5-56C0-80C5340C01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1CB8C-85E8-6441-8DB0-6274F310FB87}" type="datetimeFigureOut">
              <a:rPr lang="de-DE" smtClean="0"/>
              <a:t>20.11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02591C0-5B98-9D5D-EE98-C1C2738B2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28BA25E-0BF3-50CB-DFE1-7A0ED8C624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2128C-0E6E-FA46-AD2A-9E546E6645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057994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AB1C13C-A4FA-2AE8-7CF3-0041BFF0C8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4160F03-019C-679D-A7F6-C1FBC91212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8F30A7C-75C8-562F-C8C4-1563F680C6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1CB8C-85E8-6441-8DB0-6274F310FB87}" type="datetimeFigureOut">
              <a:rPr lang="de-DE" smtClean="0"/>
              <a:t>20.11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10A1805-07CA-F027-63C8-E768A3AE92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609C322-63D4-0F8E-15AE-9F3150D1A5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2128C-0E6E-FA46-AD2A-9E546E6645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6330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36E0E84-5CE0-D451-6136-98AA49B39D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5999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B290F4E-20E2-4ABA-8C64-C7A0498A00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3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187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373" indent="0">
              <a:buNone/>
              <a:defRPr sz="1801">
                <a:solidFill>
                  <a:schemeClr val="tx1">
                    <a:tint val="82000"/>
                  </a:schemeClr>
                </a:solidFill>
              </a:defRPr>
            </a:lvl3pPr>
            <a:lvl4pPr marL="137156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746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5933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119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306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493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4E3CCF8-2777-CFB5-C8E1-239BA7A7C7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1CB8C-85E8-6441-8DB0-6274F310FB87}" type="datetimeFigureOut">
              <a:rPr lang="de-DE" smtClean="0"/>
              <a:t>20.11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4F3068C-AB77-4906-4202-27A5A6CDB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61C7AFE-BA44-B416-AD59-1FC7E323B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2128C-0E6E-FA46-AD2A-9E546E6645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1717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7F956BC-7261-8AE8-D258-00778B5842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4E45A55-9DBD-2A9D-B3CC-2C6F00BC3F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3C3AC84-14BB-7E03-40B5-99375BDEAD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4602157-C708-6562-CC80-2B9526F0F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1CB8C-85E8-6441-8DB0-6274F310FB87}" type="datetimeFigureOut">
              <a:rPr lang="de-DE" smtClean="0"/>
              <a:t>20.11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18E8A10-8F04-3592-88D8-0208A2563C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BBA2270-1ED4-D44B-4F20-16C2D10CB1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2128C-0E6E-FA46-AD2A-9E546E6645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8039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74DA3A8-8601-30F7-1BCA-D913C6C582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6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9D81CF3-F041-6824-9D5E-783CDC8387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1" y="1681164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7" indent="0">
              <a:buNone/>
              <a:defRPr sz="2000" b="1"/>
            </a:lvl2pPr>
            <a:lvl3pPr marL="914373" indent="0">
              <a:buNone/>
              <a:defRPr sz="1801" b="1"/>
            </a:lvl3pPr>
            <a:lvl4pPr marL="1371560" indent="0">
              <a:buNone/>
              <a:defRPr sz="1600" b="1"/>
            </a:lvl4pPr>
            <a:lvl5pPr marL="1828746" indent="0">
              <a:buNone/>
              <a:defRPr sz="1600" b="1"/>
            </a:lvl5pPr>
            <a:lvl6pPr marL="2285933" indent="0">
              <a:buNone/>
              <a:defRPr sz="1600" b="1"/>
            </a:lvl6pPr>
            <a:lvl7pPr marL="2743119" indent="0">
              <a:buNone/>
              <a:defRPr sz="1600" b="1"/>
            </a:lvl7pPr>
            <a:lvl8pPr marL="3200306" indent="0">
              <a:buNone/>
              <a:defRPr sz="1600" b="1"/>
            </a:lvl8pPr>
            <a:lvl9pPr marL="3657493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BE00413-6A1B-D641-6CAF-B0328CDA5E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1" y="2505076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92021666-C677-E343-BB5A-064369B174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3" y="1681164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7" indent="0">
              <a:buNone/>
              <a:defRPr sz="2000" b="1"/>
            </a:lvl2pPr>
            <a:lvl3pPr marL="914373" indent="0">
              <a:buNone/>
              <a:defRPr sz="1801" b="1"/>
            </a:lvl3pPr>
            <a:lvl4pPr marL="1371560" indent="0">
              <a:buNone/>
              <a:defRPr sz="1600" b="1"/>
            </a:lvl4pPr>
            <a:lvl5pPr marL="1828746" indent="0">
              <a:buNone/>
              <a:defRPr sz="1600" b="1"/>
            </a:lvl5pPr>
            <a:lvl6pPr marL="2285933" indent="0">
              <a:buNone/>
              <a:defRPr sz="1600" b="1"/>
            </a:lvl6pPr>
            <a:lvl7pPr marL="2743119" indent="0">
              <a:buNone/>
              <a:defRPr sz="1600" b="1"/>
            </a:lvl7pPr>
            <a:lvl8pPr marL="3200306" indent="0">
              <a:buNone/>
              <a:defRPr sz="1600" b="1"/>
            </a:lvl8pPr>
            <a:lvl9pPr marL="3657493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961655B2-1BA3-8F70-10C4-0F659AB945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8E757152-2FD6-8E43-D5D3-23A3BD3133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1CB8C-85E8-6441-8DB0-6274F310FB87}" type="datetimeFigureOut">
              <a:rPr lang="de-DE" smtClean="0"/>
              <a:t>20.11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3E9A6D4D-46A9-EA9D-2863-823730FFA9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80912661-3290-BD10-DBB4-157A83E32B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2128C-0E6E-FA46-AD2A-9E546E6645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4145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B572B70-90DF-1D46-6733-F8E7EEAE3C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1F8E4093-B440-7BDD-AD8A-14AB50269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1CB8C-85E8-6441-8DB0-6274F310FB87}" type="datetimeFigureOut">
              <a:rPr lang="de-DE" smtClean="0"/>
              <a:t>20.11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B4D8BE3-306B-062D-6FD4-F7FF43774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C85CE3C8-F7CC-F3D0-9CC2-C0C5923D7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2128C-0E6E-FA46-AD2A-9E546E6645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7030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89EC9087-2FE8-7F60-4C52-5360DFE44F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1CB8C-85E8-6441-8DB0-6274F310FB87}" type="datetimeFigureOut">
              <a:rPr lang="de-DE" smtClean="0"/>
              <a:t>20.11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1AC19244-99B3-B00F-F905-09339450B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68F1E03-3B66-15D1-2618-1E0DF27C8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2128C-0E6E-FA46-AD2A-9E546E6645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451868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B8B07A6-F07E-9CFF-A6C2-A6534C2221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C00A824-E6A4-2B0D-6135-60780D4380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90" y="987426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4595003-BE10-4B1E-625E-46382E1D07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7" indent="0">
              <a:buNone/>
              <a:defRPr sz="1401"/>
            </a:lvl2pPr>
            <a:lvl3pPr marL="914373" indent="0">
              <a:buNone/>
              <a:defRPr sz="1200"/>
            </a:lvl3pPr>
            <a:lvl4pPr marL="1371560" indent="0">
              <a:buNone/>
              <a:defRPr sz="1001"/>
            </a:lvl4pPr>
            <a:lvl5pPr marL="1828746" indent="0">
              <a:buNone/>
              <a:defRPr sz="1001"/>
            </a:lvl5pPr>
            <a:lvl6pPr marL="2285933" indent="0">
              <a:buNone/>
              <a:defRPr sz="1001"/>
            </a:lvl6pPr>
            <a:lvl7pPr marL="2743119" indent="0">
              <a:buNone/>
              <a:defRPr sz="1001"/>
            </a:lvl7pPr>
            <a:lvl8pPr marL="3200306" indent="0">
              <a:buNone/>
              <a:defRPr sz="1001"/>
            </a:lvl8pPr>
            <a:lvl9pPr marL="3657493" indent="0">
              <a:buNone/>
              <a:defRPr sz="100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3E184BE-A404-A622-A347-280100385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1CB8C-85E8-6441-8DB0-6274F310FB87}" type="datetimeFigureOut">
              <a:rPr lang="de-DE" smtClean="0"/>
              <a:t>20.11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F4EB469-BEF4-636C-8108-374FEA035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4D7561F-24A0-923D-2849-2F70A7265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2128C-0E6E-FA46-AD2A-9E546E6645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36558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2C37668-8B98-DFEC-25F8-91992852DF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BA7AA685-D717-45EC-5CB2-A5A17A9587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90" y="987426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7" indent="0">
              <a:buNone/>
              <a:defRPr sz="2800"/>
            </a:lvl2pPr>
            <a:lvl3pPr marL="914373" indent="0">
              <a:buNone/>
              <a:defRPr sz="2400"/>
            </a:lvl3pPr>
            <a:lvl4pPr marL="1371560" indent="0">
              <a:buNone/>
              <a:defRPr sz="2000"/>
            </a:lvl4pPr>
            <a:lvl5pPr marL="1828746" indent="0">
              <a:buNone/>
              <a:defRPr sz="2000"/>
            </a:lvl5pPr>
            <a:lvl6pPr marL="2285933" indent="0">
              <a:buNone/>
              <a:defRPr sz="2000"/>
            </a:lvl6pPr>
            <a:lvl7pPr marL="2743119" indent="0">
              <a:buNone/>
              <a:defRPr sz="2000"/>
            </a:lvl7pPr>
            <a:lvl8pPr marL="3200306" indent="0">
              <a:buNone/>
              <a:defRPr sz="2000"/>
            </a:lvl8pPr>
            <a:lvl9pPr marL="3657493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17B4F7B-D744-8EC7-E3E7-29386A5A4C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7" indent="0">
              <a:buNone/>
              <a:defRPr sz="1401"/>
            </a:lvl2pPr>
            <a:lvl3pPr marL="914373" indent="0">
              <a:buNone/>
              <a:defRPr sz="1200"/>
            </a:lvl3pPr>
            <a:lvl4pPr marL="1371560" indent="0">
              <a:buNone/>
              <a:defRPr sz="1001"/>
            </a:lvl4pPr>
            <a:lvl5pPr marL="1828746" indent="0">
              <a:buNone/>
              <a:defRPr sz="1001"/>
            </a:lvl5pPr>
            <a:lvl6pPr marL="2285933" indent="0">
              <a:buNone/>
              <a:defRPr sz="1001"/>
            </a:lvl6pPr>
            <a:lvl7pPr marL="2743119" indent="0">
              <a:buNone/>
              <a:defRPr sz="1001"/>
            </a:lvl7pPr>
            <a:lvl8pPr marL="3200306" indent="0">
              <a:buNone/>
              <a:defRPr sz="1001"/>
            </a:lvl8pPr>
            <a:lvl9pPr marL="3657493" indent="0">
              <a:buNone/>
              <a:defRPr sz="100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6E6518D-9869-0810-F9F0-BC95DA867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1CB8C-85E8-6441-8DB0-6274F310FB87}" type="datetimeFigureOut">
              <a:rPr lang="de-DE" smtClean="0"/>
              <a:t>20.11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C8A89EA-DD87-3227-FC06-15366ABB9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8640D7C-15B2-1167-467A-9171BAE9C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92128C-0E6E-FA46-AD2A-9E546E6645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7388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58456296-10F2-C04B-12F8-24055EAF9F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4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123C77E-F99C-0FF8-16D3-3E6CF2F2BC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4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E6EAC25-2AC6-07BE-F7D4-ADE3712A05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B1CB8C-85E8-6441-8DB0-6274F310FB87}" type="datetimeFigureOut">
              <a:rPr lang="de-DE" smtClean="0"/>
              <a:t>20.11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055C055-2B74-D744-B15A-0C4DBB2D26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4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6FABF6F-3231-ADFC-D9B6-02E444F08F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092128C-0E6E-FA46-AD2A-9E546E6645E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8377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73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5" indent="-228595" algn="l" defTabSz="914373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1" indent="-228595" algn="l" defTabSz="91437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67" indent="-228595" algn="l" defTabSz="91437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54" indent="-228595" algn="l" defTabSz="91437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1" indent="-228595" algn="l" defTabSz="91437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526" indent="-228595" algn="l" defTabSz="91437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714" indent="-228595" algn="l" defTabSz="91437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8900" indent="-228595" algn="l" defTabSz="91437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086" indent="-228595" algn="l" defTabSz="91437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37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187" algn="l" defTabSz="91437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373" algn="l" defTabSz="91437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0" algn="l" defTabSz="91437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746" algn="l" defTabSz="91437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5933" algn="l" defTabSz="91437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119" algn="l" defTabSz="91437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306" algn="l" defTabSz="91437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493" algn="l" defTabSz="91437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uppieren 29">
            <a:extLst>
              <a:ext uri="{FF2B5EF4-FFF2-40B4-BE49-F238E27FC236}">
                <a16:creationId xmlns:a16="http://schemas.microsoft.com/office/drawing/2014/main" id="{847FF854-D821-66BC-218B-EB59A661274B}"/>
              </a:ext>
            </a:extLst>
          </p:cNvPr>
          <p:cNvGrpSpPr/>
          <p:nvPr/>
        </p:nvGrpSpPr>
        <p:grpSpPr>
          <a:xfrm>
            <a:off x="190325" y="375559"/>
            <a:ext cx="11901079" cy="6175921"/>
            <a:chOff x="190325" y="375559"/>
            <a:chExt cx="11901079" cy="6175921"/>
          </a:xfrm>
        </p:grpSpPr>
        <p:sp>
          <p:nvSpPr>
            <p:cNvPr id="5" name="Textfeld 4">
              <a:extLst>
                <a:ext uri="{FF2B5EF4-FFF2-40B4-BE49-F238E27FC236}">
                  <a16:creationId xmlns:a16="http://schemas.microsoft.com/office/drawing/2014/main" id="{6C51A476-74E6-9F82-8DCB-AE290ADEC474}"/>
                </a:ext>
              </a:extLst>
            </p:cNvPr>
            <p:cNvSpPr txBox="1"/>
            <p:nvPr/>
          </p:nvSpPr>
          <p:spPr>
            <a:xfrm>
              <a:off x="3919395" y="406337"/>
              <a:ext cx="3825085" cy="132343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iffuse astrocytoma and </a:t>
              </a:r>
            </a:p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oligodendroglioma WHO grade 2 + 3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identified from surgical records 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(1992-2023)</a:t>
              </a:r>
            </a:p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=327</a:t>
              </a:r>
            </a:p>
          </p:txBody>
        </p:sp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815A9FAF-65BE-DAEF-5176-3C09B28CDABB}"/>
                </a:ext>
              </a:extLst>
            </p:cNvPr>
            <p:cNvSpPr txBox="1"/>
            <p:nvPr/>
          </p:nvSpPr>
          <p:spPr>
            <a:xfrm>
              <a:off x="190325" y="375559"/>
              <a:ext cx="3368230" cy="138499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12700">
              <a:solidFill>
                <a:schemeClr val="tx1"/>
              </a:solidFill>
              <a:prstDash val="sysDash"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nclusion criteria:</a:t>
              </a:r>
            </a:p>
            <a:p>
              <a:pPr marL="285738" indent="-285738">
                <a:buFontTx/>
                <a:buChar char="-"/>
              </a:pP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IDH mutation</a:t>
              </a:r>
            </a:p>
            <a:p>
              <a:pPr marL="285738" indent="-285738">
                <a:buFontTx/>
                <a:buChar char="-"/>
              </a:pP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WHO 2016-2021</a:t>
              </a:r>
            </a:p>
            <a:p>
              <a:pPr marL="285738" indent="-285738">
                <a:buFontTx/>
                <a:buChar char="-"/>
              </a:pP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ubtype-defining markers available</a:t>
              </a:r>
            </a:p>
            <a:p>
              <a:pPr marL="285738" indent="-285738">
                <a:buFontTx/>
                <a:buChar char="-"/>
              </a:pP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upratentorial, hemispheric location </a:t>
              </a:r>
            </a:p>
            <a:p>
              <a:pPr marL="285738" indent="-285738">
                <a:buFontTx/>
                <a:buChar char="-"/>
              </a:pP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igitalized MRI available</a:t>
              </a:r>
            </a:p>
          </p:txBody>
        </p: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F8FB534D-3C0B-68EF-C37F-280205A8F9CA}"/>
                </a:ext>
              </a:extLst>
            </p:cNvPr>
            <p:cNvSpPr txBox="1"/>
            <p:nvPr/>
          </p:nvSpPr>
          <p:spPr>
            <a:xfrm>
              <a:off x="3919394" y="2423940"/>
              <a:ext cx="3825085" cy="83099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Radiographic evidence of 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tumor progression/recurrence</a:t>
              </a:r>
            </a:p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=188</a:t>
              </a:r>
            </a:p>
          </p:txBody>
        </p:sp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1A597704-DBA2-94CB-9CD9-D1B4AFC594F6}"/>
                </a:ext>
              </a:extLst>
            </p:cNvPr>
            <p:cNvSpPr txBox="1"/>
            <p:nvPr/>
          </p:nvSpPr>
          <p:spPr>
            <a:xfrm>
              <a:off x="8112430" y="2588428"/>
              <a:ext cx="3978974" cy="203132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12700">
              <a:solidFill>
                <a:schemeClr val="tx1"/>
              </a:solidFill>
              <a:prstDash val="sysDash"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xclusion criteria:</a:t>
              </a: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-    Treatment refused (n=7)</a:t>
              </a:r>
            </a:p>
            <a:p>
              <a:pPr marL="285738" indent="-285738">
                <a:buFontTx/>
                <a:buChar char="-"/>
              </a:pP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o vital tumor at repeat resection (n=4)</a:t>
              </a:r>
            </a:p>
            <a:p>
              <a:pPr marL="285738" indent="-285738">
                <a:buFontTx/>
                <a:buChar char="-"/>
              </a:pP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Repeat resection elsewhere (n=2)</a:t>
              </a:r>
            </a:p>
            <a:p>
              <a:pPr marL="285738" indent="-285738">
                <a:buFontTx/>
                <a:buChar char="-"/>
              </a:pP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strocytoma, CDKN2A/B homo del (n=4)</a:t>
              </a:r>
            </a:p>
            <a:p>
              <a:pPr marL="285738" indent="-285738">
                <a:buFontTx/>
                <a:buChar char="-"/>
              </a:pP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iagnosis of “secondary glioblastoma” (n=5)</a:t>
              </a:r>
            </a:p>
            <a:p>
              <a:pPr marL="285738" indent="-285738">
                <a:buFontTx/>
                <a:buChar char="-"/>
              </a:pP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assive bilateral tumor extension (n=3)</a:t>
              </a:r>
            </a:p>
            <a:p>
              <a:pPr marL="285738" indent="-285738">
                <a:buFontTx/>
                <a:buChar char="-"/>
              </a:pP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aser interstitial </a:t>
              </a:r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thermal therapy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(n=1)</a:t>
              </a:r>
            </a:p>
            <a:p>
              <a:pPr marL="285738" indent="-285738">
                <a:buFontTx/>
                <a:buChar char="-"/>
              </a:pP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o digitalized MRI available (n=14)</a:t>
              </a:r>
            </a:p>
          </p:txBody>
        </p:sp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ECF196D4-B0FC-F18D-AF32-EDF0C6871A2D}"/>
                </a:ext>
              </a:extLst>
            </p:cNvPr>
            <p:cNvSpPr txBox="1"/>
            <p:nvPr/>
          </p:nvSpPr>
          <p:spPr>
            <a:xfrm>
              <a:off x="1834353" y="5720483"/>
              <a:ext cx="2694969" cy="83099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urgical cohort: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Resection at 1</a:t>
              </a:r>
              <a:r>
                <a:rPr lang="en-US" sz="1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recurrence</a:t>
              </a:r>
            </a:p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=50</a:t>
              </a:r>
            </a:p>
          </p:txBody>
        </p: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7CD212D3-0C4B-DAB6-B8A5-DBF757DD72FE}"/>
                </a:ext>
              </a:extLst>
            </p:cNvPr>
            <p:cNvSpPr txBox="1"/>
            <p:nvPr/>
          </p:nvSpPr>
          <p:spPr>
            <a:xfrm>
              <a:off x="7286164" y="5720483"/>
              <a:ext cx="3825086" cy="83099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on-surgical cohort: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Radiotherapy and/or systemic treatment</a:t>
              </a:r>
            </a:p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=98</a:t>
              </a: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7E25ADD2-8DD0-F69B-154C-6E8D937C0685}"/>
                </a:ext>
              </a:extLst>
            </p:cNvPr>
            <p:cNvSpPr txBox="1"/>
            <p:nvPr/>
          </p:nvSpPr>
          <p:spPr>
            <a:xfrm>
              <a:off x="3919395" y="3949101"/>
              <a:ext cx="3825086" cy="1077218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Recurrent diffuse astrocytoma and </a:t>
              </a:r>
            </a:p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oligodendroglioma WHO grade 2 + 3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(2001-2023)</a:t>
              </a:r>
            </a:p>
            <a:p>
              <a:pPr algn="ctr"/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n=148</a:t>
              </a:r>
            </a:p>
          </p:txBody>
        </p:sp>
        <p:cxnSp>
          <p:nvCxnSpPr>
            <p:cNvPr id="13" name="Gerade Verbindung mit Pfeil 12">
              <a:extLst>
                <a:ext uri="{FF2B5EF4-FFF2-40B4-BE49-F238E27FC236}">
                  <a16:creationId xmlns:a16="http://schemas.microsoft.com/office/drawing/2014/main" id="{3F57D5EE-E845-336F-BBBF-FD221064AD0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45384" y="1788858"/>
              <a:ext cx="1" cy="576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Gerade Verbindung mit Pfeil 15">
              <a:extLst>
                <a:ext uri="{FF2B5EF4-FFF2-40B4-BE49-F238E27FC236}">
                  <a16:creationId xmlns:a16="http://schemas.microsoft.com/office/drawing/2014/main" id="{F851EAB0-6886-E76F-7277-8E1A065629C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45384" y="3314019"/>
              <a:ext cx="1" cy="57600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Gerade Verbindung 17">
              <a:extLst>
                <a:ext uri="{FF2B5EF4-FFF2-40B4-BE49-F238E27FC236}">
                  <a16:creationId xmlns:a16="http://schemas.microsoft.com/office/drawing/2014/main" id="{B5C19F7E-8589-0A12-62E5-A5AFB97A5149}"/>
                </a:ext>
              </a:extLst>
            </p:cNvPr>
            <p:cNvCxnSpPr>
              <a:cxnSpLocks/>
            </p:cNvCxnSpPr>
            <p:nvPr/>
          </p:nvCxnSpPr>
          <p:spPr>
            <a:xfrm>
              <a:off x="3181837" y="5392271"/>
              <a:ext cx="601687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rade Verbindung 20">
              <a:extLst>
                <a:ext uri="{FF2B5EF4-FFF2-40B4-BE49-F238E27FC236}">
                  <a16:creationId xmlns:a16="http://schemas.microsoft.com/office/drawing/2014/main" id="{2EE43828-7530-A1DC-F91A-EF7FA6040FE1}"/>
                </a:ext>
              </a:extLst>
            </p:cNvPr>
            <p:cNvCxnSpPr>
              <a:cxnSpLocks/>
            </p:cNvCxnSpPr>
            <p:nvPr/>
          </p:nvCxnSpPr>
          <p:spPr>
            <a:xfrm>
              <a:off x="3181837" y="5392271"/>
              <a:ext cx="0" cy="201705"/>
            </a:xfrm>
            <a:prstGeom prst="line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Gerade Verbindung 21">
              <a:extLst>
                <a:ext uri="{FF2B5EF4-FFF2-40B4-BE49-F238E27FC236}">
                  <a16:creationId xmlns:a16="http://schemas.microsoft.com/office/drawing/2014/main" id="{510E411B-A7D9-F50E-6902-6BE290CD2D2E}"/>
                </a:ext>
              </a:extLst>
            </p:cNvPr>
            <p:cNvCxnSpPr>
              <a:cxnSpLocks/>
            </p:cNvCxnSpPr>
            <p:nvPr/>
          </p:nvCxnSpPr>
          <p:spPr>
            <a:xfrm>
              <a:off x="9197160" y="5392271"/>
              <a:ext cx="0" cy="201705"/>
            </a:xfrm>
            <a:prstGeom prst="line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Gerade Verbindung mit Pfeil 24">
              <a:extLst>
                <a:ext uri="{FF2B5EF4-FFF2-40B4-BE49-F238E27FC236}">
                  <a16:creationId xmlns:a16="http://schemas.microsoft.com/office/drawing/2014/main" id="{DAF4E56A-B32C-CF6D-20A0-E092527EDA0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849867" y="5066612"/>
              <a:ext cx="1" cy="28800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Gerade Verbindung 26">
              <a:extLst>
                <a:ext uri="{FF2B5EF4-FFF2-40B4-BE49-F238E27FC236}">
                  <a16:creationId xmlns:a16="http://schemas.microsoft.com/office/drawing/2014/main" id="{FC30ABB6-5A94-2F47-5405-60C37B4A1C91}"/>
                </a:ext>
              </a:extLst>
            </p:cNvPr>
            <p:cNvCxnSpPr>
              <a:endCxn id="8" idx="1"/>
            </p:cNvCxnSpPr>
            <p:nvPr/>
          </p:nvCxnSpPr>
          <p:spPr>
            <a:xfrm>
              <a:off x="5845384" y="3602019"/>
              <a:ext cx="2267046" cy="2072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Gerade Verbindung 28">
              <a:extLst>
                <a:ext uri="{FF2B5EF4-FFF2-40B4-BE49-F238E27FC236}">
                  <a16:creationId xmlns:a16="http://schemas.microsoft.com/office/drawing/2014/main" id="{BABFDFD7-BA59-D0BD-7A23-F9DE56C8E8E8}"/>
                </a:ext>
              </a:extLst>
            </p:cNvPr>
            <p:cNvCxnSpPr>
              <a:stCxn id="6" idx="3"/>
              <a:endCxn id="5" idx="1"/>
            </p:cNvCxnSpPr>
            <p:nvPr/>
          </p:nvCxnSpPr>
          <p:spPr>
            <a:xfrm>
              <a:off x="3558555" y="1068057"/>
              <a:ext cx="36084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9753763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5</Words>
  <Application>Microsoft Macintosh PowerPoint</Application>
  <PresentationFormat>Breitbild</PresentationFormat>
  <Paragraphs>3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rosoft Office User</dc:creator>
  <cp:lastModifiedBy>Microsoft Office User</cp:lastModifiedBy>
  <cp:revision>8</cp:revision>
  <dcterms:created xsi:type="dcterms:W3CDTF">2025-11-17T17:46:34Z</dcterms:created>
  <dcterms:modified xsi:type="dcterms:W3CDTF">2025-11-20T17:00:18Z</dcterms:modified>
</cp:coreProperties>
</file>